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9" r:id="rId3"/>
    <p:sldId id="266" r:id="rId4"/>
    <p:sldId id="268" r:id="rId5"/>
    <p:sldId id="263" r:id="rId6"/>
    <p:sldId id="265" r:id="rId7"/>
    <p:sldId id="267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30A0"/>
    <a:srgbClr val="000000"/>
    <a:srgbClr val="361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3" autoAdjust="0"/>
    <p:restoredTop sz="94660"/>
  </p:normalViewPr>
  <p:slideViewPr>
    <p:cSldViewPr snapToGrid="0">
      <p:cViewPr>
        <p:scale>
          <a:sx n="140" d="100"/>
          <a:sy n="140" d="100"/>
        </p:scale>
        <p:origin x="1104" y="-19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541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171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77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976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996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03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781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702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2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6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831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775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2588D-757B-4B60-9ED5-A6EB386DD7B8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D9676-9152-482F-87F4-9F5D9DC79C8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277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867664" y="185351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/>
          <a:srcRect t="4144" r="3966" b="4680"/>
          <a:stretch/>
        </p:blipFill>
        <p:spPr>
          <a:xfrm>
            <a:off x="24484" y="968990"/>
            <a:ext cx="6833516" cy="4624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58804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867664" y="185351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/>
          <a:srcRect l="3397" r="2686"/>
          <a:stretch/>
        </p:blipFill>
        <p:spPr>
          <a:xfrm>
            <a:off x="15394" y="1117395"/>
            <a:ext cx="6842606" cy="6348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2999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867664" y="185351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l="1876" r="4108"/>
          <a:stretch/>
        </p:blipFill>
        <p:spPr>
          <a:xfrm>
            <a:off x="132410" y="1056707"/>
            <a:ext cx="6651567" cy="3455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5824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CuadroTexto 24"/>
          <p:cNvSpPr txBox="1"/>
          <p:nvPr/>
        </p:nvSpPr>
        <p:spPr>
          <a:xfrm>
            <a:off x="3979934" y="17587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Imagen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43034"/>
            <a:ext cx="6858000" cy="48678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05831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979934" y="17587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102" y="862148"/>
            <a:ext cx="6343210" cy="6280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00668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3979933" y="11373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6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7006" y="604212"/>
            <a:ext cx="3669722" cy="9165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86074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979934" y="17587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UY" b="1" dirty="0">
                <a:latin typeface="Arial" panose="020B0604020202020204" pitchFamily="34" charset="0"/>
                <a:cs typeface="Arial" panose="020B0604020202020204" pitchFamily="34" charset="0"/>
              </a:rPr>
              <a:t> Figure 7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9375" y="1193448"/>
            <a:ext cx="4351285" cy="3246636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2425878" y="885671"/>
            <a:ext cx="2621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sz="1400" b="1" dirty="0">
                <a:latin typeface="Arial" panose="020B0604020202020204" pitchFamily="34" charset="0"/>
                <a:cs typeface="Arial" panose="020B0604020202020204" pitchFamily="34" charset="0"/>
              </a:rPr>
              <a:t>CCM </a:t>
            </a:r>
            <a:r>
              <a:rPr lang="es-UY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s-UY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R</a:t>
            </a:r>
            <a:r>
              <a:rPr lang="es-UY" sz="1400" b="1" dirty="0" err="1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s-UY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s-UY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UY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M </a:t>
            </a:r>
            <a:r>
              <a:rPr lang="es-UY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geth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7169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4</TotalTime>
  <Words>27</Words>
  <Application>Microsoft Office PowerPoint</Application>
  <PresentationFormat>A4 (210 x 297 mm)</PresentationFormat>
  <Paragraphs>8</Paragraphs>
  <Slides>7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Dixguel03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 de Windows</dc:creator>
  <cp:lastModifiedBy>Usuario de Windows</cp:lastModifiedBy>
  <cp:revision>115</cp:revision>
  <dcterms:created xsi:type="dcterms:W3CDTF">2025-07-31T21:06:22Z</dcterms:created>
  <dcterms:modified xsi:type="dcterms:W3CDTF">2025-11-14T18:50:04Z</dcterms:modified>
</cp:coreProperties>
</file>